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0" r:id="rId2"/>
  </p:sldIdLst>
  <p:sldSz cx="8820150" cy="121681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392"/>
    <p:restoredTop sz="94690"/>
  </p:normalViewPr>
  <p:slideViewPr>
    <p:cSldViewPr snapToGrid="0" snapToObjects="1">
      <p:cViewPr varScale="1">
        <p:scale>
          <a:sx n="51" d="100"/>
          <a:sy n="51" d="100"/>
        </p:scale>
        <p:origin x="2576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61511" y="1991415"/>
            <a:ext cx="7497128" cy="4236332"/>
          </a:xfrm>
        </p:spPr>
        <p:txBody>
          <a:bodyPr anchor="b"/>
          <a:lstStyle>
            <a:lvl1pPr algn="ctr">
              <a:defRPr sz="57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2519" y="6391116"/>
            <a:ext cx="6615113" cy="2937828"/>
          </a:xfrm>
        </p:spPr>
        <p:txBody>
          <a:bodyPr/>
          <a:lstStyle>
            <a:lvl1pPr marL="0" indent="0" algn="ctr">
              <a:buNone/>
              <a:defRPr sz="2315"/>
            </a:lvl1pPr>
            <a:lvl2pPr marL="441015" indent="0" algn="ctr">
              <a:buNone/>
              <a:defRPr sz="1929"/>
            </a:lvl2pPr>
            <a:lvl3pPr marL="882030" indent="0" algn="ctr">
              <a:buNone/>
              <a:defRPr sz="1736"/>
            </a:lvl3pPr>
            <a:lvl4pPr marL="1323045" indent="0" algn="ctr">
              <a:buNone/>
              <a:defRPr sz="1543"/>
            </a:lvl4pPr>
            <a:lvl5pPr marL="1764060" indent="0" algn="ctr">
              <a:buNone/>
              <a:defRPr sz="1543"/>
            </a:lvl5pPr>
            <a:lvl6pPr marL="2205076" indent="0" algn="ctr">
              <a:buNone/>
              <a:defRPr sz="1543"/>
            </a:lvl6pPr>
            <a:lvl7pPr marL="2646091" indent="0" algn="ctr">
              <a:buNone/>
              <a:defRPr sz="1543"/>
            </a:lvl7pPr>
            <a:lvl8pPr marL="3087106" indent="0" algn="ctr">
              <a:buNone/>
              <a:defRPr sz="1543"/>
            </a:lvl8pPr>
            <a:lvl9pPr marL="3528121" indent="0" algn="ctr">
              <a:buNone/>
              <a:defRPr sz="154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114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772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11920" y="647843"/>
            <a:ext cx="1901845" cy="103119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6386" y="647843"/>
            <a:ext cx="5595283" cy="103119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932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405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1792" y="3033601"/>
            <a:ext cx="7607379" cy="5061627"/>
          </a:xfrm>
        </p:spPr>
        <p:txBody>
          <a:bodyPr anchor="b"/>
          <a:lstStyle>
            <a:lvl1pPr>
              <a:defRPr sz="57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1792" y="8143113"/>
            <a:ext cx="7607379" cy="2661790"/>
          </a:xfrm>
        </p:spPr>
        <p:txBody>
          <a:bodyPr/>
          <a:lstStyle>
            <a:lvl1pPr marL="0" indent="0">
              <a:buNone/>
              <a:defRPr sz="2315">
                <a:solidFill>
                  <a:schemeClr val="tx1"/>
                </a:solidFill>
              </a:defRPr>
            </a:lvl1pPr>
            <a:lvl2pPr marL="441015" indent="0">
              <a:buNone/>
              <a:defRPr sz="1929">
                <a:solidFill>
                  <a:schemeClr val="tx1">
                    <a:tint val="75000"/>
                  </a:schemeClr>
                </a:solidFill>
              </a:defRPr>
            </a:lvl2pPr>
            <a:lvl3pPr marL="882030" indent="0">
              <a:buNone/>
              <a:defRPr sz="1736">
                <a:solidFill>
                  <a:schemeClr val="tx1">
                    <a:tint val="75000"/>
                  </a:schemeClr>
                </a:solidFill>
              </a:defRPr>
            </a:lvl3pPr>
            <a:lvl4pPr marL="1323045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4pPr>
            <a:lvl5pPr marL="1764060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5pPr>
            <a:lvl6pPr marL="2205076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6pPr>
            <a:lvl7pPr marL="2646091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7pPr>
            <a:lvl8pPr marL="3087106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8pPr>
            <a:lvl9pPr marL="3528121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116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6385" y="3239216"/>
            <a:ext cx="3748564" cy="77206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5201" y="3239216"/>
            <a:ext cx="3748564" cy="77206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261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647846"/>
            <a:ext cx="7607379" cy="235195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7535" y="2982897"/>
            <a:ext cx="3731336" cy="146187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1015" indent="0">
              <a:buNone/>
              <a:defRPr sz="1929" b="1"/>
            </a:lvl2pPr>
            <a:lvl3pPr marL="882030" indent="0">
              <a:buNone/>
              <a:defRPr sz="1736" b="1"/>
            </a:lvl3pPr>
            <a:lvl4pPr marL="1323045" indent="0">
              <a:buNone/>
              <a:defRPr sz="1543" b="1"/>
            </a:lvl4pPr>
            <a:lvl5pPr marL="1764060" indent="0">
              <a:buNone/>
              <a:defRPr sz="1543" b="1"/>
            </a:lvl5pPr>
            <a:lvl6pPr marL="2205076" indent="0">
              <a:buNone/>
              <a:defRPr sz="1543" b="1"/>
            </a:lvl6pPr>
            <a:lvl7pPr marL="2646091" indent="0">
              <a:buNone/>
              <a:defRPr sz="1543" b="1"/>
            </a:lvl7pPr>
            <a:lvl8pPr marL="3087106" indent="0">
              <a:buNone/>
              <a:defRPr sz="1543" b="1"/>
            </a:lvl8pPr>
            <a:lvl9pPr marL="3528121" indent="0">
              <a:buNone/>
              <a:defRPr sz="154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7535" y="4444769"/>
            <a:ext cx="3731336" cy="65375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65201" y="2982897"/>
            <a:ext cx="3749713" cy="146187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1015" indent="0">
              <a:buNone/>
              <a:defRPr sz="1929" b="1"/>
            </a:lvl2pPr>
            <a:lvl3pPr marL="882030" indent="0">
              <a:buNone/>
              <a:defRPr sz="1736" b="1"/>
            </a:lvl3pPr>
            <a:lvl4pPr marL="1323045" indent="0">
              <a:buNone/>
              <a:defRPr sz="1543" b="1"/>
            </a:lvl4pPr>
            <a:lvl5pPr marL="1764060" indent="0">
              <a:buNone/>
              <a:defRPr sz="1543" b="1"/>
            </a:lvl5pPr>
            <a:lvl6pPr marL="2205076" indent="0">
              <a:buNone/>
              <a:defRPr sz="1543" b="1"/>
            </a:lvl6pPr>
            <a:lvl7pPr marL="2646091" indent="0">
              <a:buNone/>
              <a:defRPr sz="1543" b="1"/>
            </a:lvl7pPr>
            <a:lvl8pPr marL="3087106" indent="0">
              <a:buNone/>
              <a:defRPr sz="1543" b="1"/>
            </a:lvl8pPr>
            <a:lvl9pPr marL="3528121" indent="0">
              <a:buNone/>
              <a:defRPr sz="154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65201" y="4444769"/>
            <a:ext cx="3749713" cy="65375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232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195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593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1212"/>
            <a:ext cx="2844728" cy="2839244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49713" y="1751997"/>
            <a:ext cx="4465201" cy="8647300"/>
          </a:xfrm>
        </p:spPr>
        <p:txBody>
          <a:bodyPr/>
          <a:lstStyle>
            <a:lvl1pPr>
              <a:defRPr sz="3087"/>
            </a:lvl1pPr>
            <a:lvl2pPr>
              <a:defRPr sz="2701"/>
            </a:lvl2pPr>
            <a:lvl3pPr>
              <a:defRPr sz="2315"/>
            </a:lvl3pPr>
            <a:lvl4pPr>
              <a:defRPr sz="1929"/>
            </a:lvl4pPr>
            <a:lvl5pPr>
              <a:defRPr sz="1929"/>
            </a:lvl5pPr>
            <a:lvl6pPr>
              <a:defRPr sz="1929"/>
            </a:lvl6pPr>
            <a:lvl7pPr>
              <a:defRPr sz="1929"/>
            </a:lvl7pPr>
            <a:lvl8pPr>
              <a:defRPr sz="1929"/>
            </a:lvl8pPr>
            <a:lvl9pPr>
              <a:defRPr sz="192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0456"/>
            <a:ext cx="2844728" cy="6762922"/>
          </a:xfrm>
        </p:spPr>
        <p:txBody>
          <a:bodyPr/>
          <a:lstStyle>
            <a:lvl1pPr marL="0" indent="0">
              <a:buNone/>
              <a:defRPr sz="1543"/>
            </a:lvl1pPr>
            <a:lvl2pPr marL="441015" indent="0">
              <a:buNone/>
              <a:defRPr sz="1350"/>
            </a:lvl2pPr>
            <a:lvl3pPr marL="882030" indent="0">
              <a:buNone/>
              <a:defRPr sz="1158"/>
            </a:lvl3pPr>
            <a:lvl4pPr marL="1323045" indent="0">
              <a:buNone/>
              <a:defRPr sz="965"/>
            </a:lvl4pPr>
            <a:lvl5pPr marL="1764060" indent="0">
              <a:buNone/>
              <a:defRPr sz="965"/>
            </a:lvl5pPr>
            <a:lvl6pPr marL="2205076" indent="0">
              <a:buNone/>
              <a:defRPr sz="965"/>
            </a:lvl6pPr>
            <a:lvl7pPr marL="2646091" indent="0">
              <a:buNone/>
              <a:defRPr sz="965"/>
            </a:lvl7pPr>
            <a:lvl8pPr marL="3087106" indent="0">
              <a:buNone/>
              <a:defRPr sz="965"/>
            </a:lvl8pPr>
            <a:lvl9pPr marL="3528121" indent="0">
              <a:buNone/>
              <a:defRPr sz="9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66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1212"/>
            <a:ext cx="2844728" cy="2839244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49713" y="1751997"/>
            <a:ext cx="4465201" cy="8647300"/>
          </a:xfrm>
        </p:spPr>
        <p:txBody>
          <a:bodyPr anchor="t"/>
          <a:lstStyle>
            <a:lvl1pPr marL="0" indent="0">
              <a:buNone/>
              <a:defRPr sz="3087"/>
            </a:lvl1pPr>
            <a:lvl2pPr marL="441015" indent="0">
              <a:buNone/>
              <a:defRPr sz="2701"/>
            </a:lvl2pPr>
            <a:lvl3pPr marL="882030" indent="0">
              <a:buNone/>
              <a:defRPr sz="2315"/>
            </a:lvl3pPr>
            <a:lvl4pPr marL="1323045" indent="0">
              <a:buNone/>
              <a:defRPr sz="1929"/>
            </a:lvl4pPr>
            <a:lvl5pPr marL="1764060" indent="0">
              <a:buNone/>
              <a:defRPr sz="1929"/>
            </a:lvl5pPr>
            <a:lvl6pPr marL="2205076" indent="0">
              <a:buNone/>
              <a:defRPr sz="1929"/>
            </a:lvl6pPr>
            <a:lvl7pPr marL="2646091" indent="0">
              <a:buNone/>
              <a:defRPr sz="1929"/>
            </a:lvl7pPr>
            <a:lvl8pPr marL="3087106" indent="0">
              <a:buNone/>
              <a:defRPr sz="1929"/>
            </a:lvl8pPr>
            <a:lvl9pPr marL="3528121" indent="0">
              <a:buNone/>
              <a:defRPr sz="192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0456"/>
            <a:ext cx="2844728" cy="6762922"/>
          </a:xfrm>
        </p:spPr>
        <p:txBody>
          <a:bodyPr/>
          <a:lstStyle>
            <a:lvl1pPr marL="0" indent="0">
              <a:buNone/>
              <a:defRPr sz="1543"/>
            </a:lvl1pPr>
            <a:lvl2pPr marL="441015" indent="0">
              <a:buNone/>
              <a:defRPr sz="1350"/>
            </a:lvl2pPr>
            <a:lvl3pPr marL="882030" indent="0">
              <a:buNone/>
              <a:defRPr sz="1158"/>
            </a:lvl3pPr>
            <a:lvl4pPr marL="1323045" indent="0">
              <a:buNone/>
              <a:defRPr sz="965"/>
            </a:lvl4pPr>
            <a:lvl5pPr marL="1764060" indent="0">
              <a:buNone/>
              <a:defRPr sz="965"/>
            </a:lvl5pPr>
            <a:lvl6pPr marL="2205076" indent="0">
              <a:buNone/>
              <a:defRPr sz="965"/>
            </a:lvl6pPr>
            <a:lvl7pPr marL="2646091" indent="0">
              <a:buNone/>
              <a:defRPr sz="965"/>
            </a:lvl7pPr>
            <a:lvl8pPr marL="3087106" indent="0">
              <a:buNone/>
              <a:defRPr sz="965"/>
            </a:lvl8pPr>
            <a:lvl9pPr marL="3528121" indent="0">
              <a:buNone/>
              <a:defRPr sz="9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771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6386" y="647846"/>
            <a:ext cx="7607379" cy="23519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6386" y="3239216"/>
            <a:ext cx="7607379" cy="77206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6385" y="11278110"/>
            <a:ext cx="1984534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0ADAF-4120-F149-B1BB-CD96FE08376F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21675" y="11278110"/>
            <a:ext cx="2976801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29231" y="11278110"/>
            <a:ext cx="1984534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D8959C-73EA-9047-AF54-F1605B552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297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82030" rtl="0" eaLnBrk="1" latinLnBrk="0" hangingPunct="1">
        <a:lnSpc>
          <a:spcPct val="90000"/>
        </a:lnSpc>
        <a:spcBef>
          <a:spcPct val="0"/>
        </a:spcBef>
        <a:buNone/>
        <a:defRPr sz="42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0508" indent="-220508" algn="l" defTabSz="882030" rtl="0" eaLnBrk="1" latinLnBrk="0" hangingPunct="1">
        <a:lnSpc>
          <a:spcPct val="90000"/>
        </a:lnSpc>
        <a:spcBef>
          <a:spcPts val="965"/>
        </a:spcBef>
        <a:buFont typeface="Arial" panose="020B0604020202020204" pitchFamily="34" charset="0"/>
        <a:buChar char="•"/>
        <a:defRPr sz="2701" kern="1200">
          <a:solidFill>
            <a:schemeClr val="tx1"/>
          </a:solidFill>
          <a:latin typeface="+mn-lt"/>
          <a:ea typeface="+mn-ea"/>
          <a:cs typeface="+mn-cs"/>
        </a:defRPr>
      </a:lvl1pPr>
      <a:lvl2pPr marL="66152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2pPr>
      <a:lvl3pPr marL="110253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3pPr>
      <a:lvl4pPr marL="154355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98456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42558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86659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30761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748629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1pPr>
      <a:lvl2pPr marL="441015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2pPr>
      <a:lvl3pPr marL="882030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3pPr>
      <a:lvl4pPr marL="1323045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764060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205076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646091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087106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528121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FF1CDC9-7A75-D84D-8E75-BC8C0004A2C5}"/>
              </a:ext>
            </a:extLst>
          </p:cNvPr>
          <p:cNvGrpSpPr>
            <a:grpSpLocks noChangeAspect="1"/>
          </p:cNvGrpSpPr>
          <p:nvPr/>
        </p:nvGrpSpPr>
        <p:grpSpPr>
          <a:xfrm>
            <a:off x="904541" y="775330"/>
            <a:ext cx="6847201" cy="6691918"/>
            <a:chOff x="24872" y="-953"/>
            <a:chExt cx="9066981" cy="886094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3AE840E-65C1-374D-B2FA-34B5953F6A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322" y="0"/>
              <a:ext cx="4253240" cy="21525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304856B-43A4-2744-A00F-6B0CA1BBA7E1}"/>
                </a:ext>
              </a:extLst>
            </p:cNvPr>
            <p:cNvSpPr txBox="1"/>
            <p:nvPr/>
          </p:nvSpPr>
          <p:spPr>
            <a:xfrm>
              <a:off x="3241487" y="5056"/>
              <a:ext cx="936525" cy="4482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T7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B96FB8B-DEA1-D948-A4CF-B5C5CE8ADD7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19601" y="-953"/>
              <a:ext cx="4400549" cy="215257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D685430-259E-A54D-9B83-EEA938DC3AAA}"/>
                </a:ext>
              </a:extLst>
            </p:cNvPr>
            <p:cNvSpPr txBox="1"/>
            <p:nvPr/>
          </p:nvSpPr>
          <p:spPr>
            <a:xfrm>
              <a:off x="7589268" y="0"/>
              <a:ext cx="1502585" cy="448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F1A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71CDE47-9BAD-5949-8C34-6FA463F5421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322" y="2264957"/>
              <a:ext cx="4292819" cy="21671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EB49E50-28A1-7041-8E4F-66FEFA4B48EC}"/>
                </a:ext>
              </a:extLst>
            </p:cNvPr>
            <p:cNvSpPr txBox="1"/>
            <p:nvPr/>
          </p:nvSpPr>
          <p:spPr>
            <a:xfrm>
              <a:off x="2979354" y="2264957"/>
              <a:ext cx="983224" cy="4482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BQ9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6A8F4C76-73D6-1E46-995B-0C6CA8592F8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19601" y="2264957"/>
              <a:ext cx="4400549" cy="21671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E43A469-B7E8-E644-85BF-AB5E8EE13324}"/>
                </a:ext>
              </a:extLst>
            </p:cNvPr>
            <p:cNvSpPr txBox="1"/>
            <p:nvPr/>
          </p:nvSpPr>
          <p:spPr>
            <a:xfrm>
              <a:off x="7421157" y="2264956"/>
              <a:ext cx="1148793" cy="4482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IPS41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531B7A7-74A4-7F43-A9AA-4210D080E97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4872" y="4544481"/>
              <a:ext cx="4303269" cy="21440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574A728-0657-414E-ABEB-1E209AEAFA63}"/>
                </a:ext>
              </a:extLst>
            </p:cNvPr>
            <p:cNvSpPr txBox="1"/>
            <p:nvPr/>
          </p:nvSpPr>
          <p:spPr>
            <a:xfrm>
              <a:off x="2979354" y="4504170"/>
              <a:ext cx="1368015" cy="448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P2A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1E292F94-3928-DD44-8B8F-FA443D34FC9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268125" y="6760575"/>
              <a:ext cx="4362121" cy="209941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6BE5CFB-B0E8-8145-AB59-EF41CB32AFDF}"/>
                </a:ext>
              </a:extLst>
            </p:cNvPr>
            <p:cNvSpPr txBox="1"/>
            <p:nvPr/>
          </p:nvSpPr>
          <p:spPr>
            <a:xfrm>
              <a:off x="5595324" y="6760575"/>
              <a:ext cx="785815" cy="4482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UA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17E86E08-9379-D341-8606-231FD50DEDA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449186" y="4488709"/>
              <a:ext cx="4370963" cy="21997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3EE6C4A-48D6-A94D-A029-583FC7A8002F}"/>
                </a:ext>
              </a:extLst>
            </p:cNvPr>
            <p:cNvSpPr txBox="1"/>
            <p:nvPr/>
          </p:nvSpPr>
          <p:spPr>
            <a:xfrm>
              <a:off x="7847042" y="4474926"/>
              <a:ext cx="815533" cy="4482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AC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DC059F69-F87C-2E44-A8FF-6DF95A157B51}"/>
              </a:ext>
            </a:extLst>
          </p:cNvPr>
          <p:cNvSpPr txBox="1"/>
          <p:nvPr/>
        </p:nvSpPr>
        <p:spPr>
          <a:xfrm>
            <a:off x="567452" y="7633711"/>
            <a:ext cx="7930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2 Fig: Melt curve generated for all the seven candidate reference gene i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. sativa</a:t>
            </a:r>
          </a:p>
        </p:txBody>
      </p:sp>
    </p:spTree>
    <p:extLst>
      <p:ext uri="{BB962C8B-B14F-4D97-AF65-F5344CB8AC3E}">
        <p14:creationId xmlns:p14="http://schemas.microsoft.com/office/powerpoint/2010/main" val="23419924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</TotalTime>
  <Words>24</Words>
  <Application>Microsoft Macintosh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kha dixit</dc:creator>
  <cp:lastModifiedBy>Microsoft Office User</cp:lastModifiedBy>
  <cp:revision>2</cp:revision>
  <dcterms:created xsi:type="dcterms:W3CDTF">2019-04-10T09:23:15Z</dcterms:created>
  <dcterms:modified xsi:type="dcterms:W3CDTF">2019-09-06T14:36:06Z</dcterms:modified>
</cp:coreProperties>
</file>